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67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5B9F02-4329-2367-3BF9-508A1A96FD56}" name="Jacquelyn Cobb" initials="JC" userId="2TKl1PY2XnxPwIKS0uSBCHS+ZbaJNCUH6usjlDDCugg=" providerId="None"/>
  <p188:author id="{640B54EB-E816-2BC3-C839-1A4EF501EB23}" name="melissa cobb" initials="mc" userId="d4810ba07ee449b0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90D3678-48F3-46B7-9302-7F8F499A40CB}" v="3" dt="2022-01-19T18:02:02.1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000"/>
    <p:restoredTop sz="95588"/>
  </p:normalViewPr>
  <p:slideViewPr>
    <p:cSldViewPr snapToGrid="0" snapToObjects="1" showGuides="1">
      <p:cViewPr varScale="1">
        <p:scale>
          <a:sx n="72" d="100"/>
          <a:sy n="72" d="100"/>
        </p:scale>
        <p:origin x="23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 snapToObjects="1" showGuides="1">
      <p:cViewPr varScale="1">
        <p:scale>
          <a:sx n="83" d="100"/>
          <a:sy n="83" d="100"/>
        </p:scale>
        <p:origin x="2904" y="192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DC50AF-3C18-0F4F-BFEB-FD99939D2827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CCFB56-C793-234A-8E48-E481E72DF32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5292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0D91AEF-E5B3-4946-A944-67B6503C5824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4152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068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835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8260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4341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686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1361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36271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7505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054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8912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091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5A1E1-0754-0C41-8909-A514C88D2B9E}" type="datetimeFigureOut">
              <a:rPr lang="en-US" smtClean="0"/>
              <a:t>1/6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E99D6-58CF-5844-B80C-CC32C74CE4D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5474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4EB22B9-8AB9-4143-9FC4-07355A91776B}"/>
              </a:ext>
            </a:extLst>
          </p:cNvPr>
          <p:cNvSpPr txBox="1"/>
          <p:nvPr/>
        </p:nvSpPr>
        <p:spPr>
          <a:xfrm>
            <a:off x="617271" y="1207777"/>
            <a:ext cx="55469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 2.  </a:t>
            </a:r>
            <a:endParaRPr lang="en-US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06FAF45-C791-CA44-B7D2-3C41D8C2D84F}"/>
              </a:ext>
            </a:extLst>
          </p:cNvPr>
          <p:cNvSpPr txBox="1"/>
          <p:nvPr/>
        </p:nvSpPr>
        <p:spPr>
          <a:xfrm>
            <a:off x="803370" y="1856647"/>
            <a:ext cx="116570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ample processin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19E3E9-91F7-344A-8297-9EB326271A88}"/>
              </a:ext>
            </a:extLst>
          </p:cNvPr>
          <p:cNvSpPr txBox="1"/>
          <p:nvPr/>
        </p:nvSpPr>
        <p:spPr>
          <a:xfrm>
            <a:off x="3071972" y="1856647"/>
            <a:ext cx="22236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low cytometry- single cell index sortin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A488897-E67E-6843-B121-BFF79B85515B}"/>
              </a:ext>
            </a:extLst>
          </p:cNvPr>
          <p:cNvSpPr txBox="1"/>
          <p:nvPr/>
        </p:nvSpPr>
        <p:spPr>
          <a:xfrm>
            <a:off x="533400" y="273735"/>
            <a:ext cx="5943600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2971800" algn="ctr"/>
                <a:tab pos="5943600" algn="r"/>
              </a:tabLst>
            </a:pPr>
            <a:r>
              <a:rPr lang="en-US" sz="105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giya</a:t>
            </a:r>
            <a:r>
              <a:rPr lang="en-US" sz="1050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t al.                                                           2		Strategies for RNA therapeutics</a:t>
            </a:r>
            <a:endParaRPr lang="en-US" sz="105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3" name="Picture 2" descr="Graphical user interface&#10;&#10;Description automatically generated">
            <a:extLst>
              <a:ext uri="{FF2B5EF4-FFF2-40B4-BE49-F238E27FC236}">
                <a16:creationId xmlns:a16="http://schemas.microsoft.com/office/drawing/2014/main" id="{1EA64644-45DC-4090-A9B0-CAFF57893C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414" y="2087479"/>
            <a:ext cx="5891171" cy="901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6718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7</TotalTime>
  <Words>24</Words>
  <Application>Microsoft Macintosh PowerPoint</Application>
  <PresentationFormat>Letter Paper (8.5x11 in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ia, Sophia,Ph.D.</dc:creator>
  <cp:lastModifiedBy>Adamia, Sophia (BIDMC - Sophia Adamia)</cp:lastModifiedBy>
  <cp:revision>101</cp:revision>
  <cp:lastPrinted>2022-01-24T23:44:57Z</cp:lastPrinted>
  <dcterms:created xsi:type="dcterms:W3CDTF">2020-05-24T06:22:11Z</dcterms:created>
  <dcterms:modified xsi:type="dcterms:W3CDTF">2023-01-06T21:30:43Z</dcterms:modified>
</cp:coreProperties>
</file>